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6" r:id="rId2"/>
    <p:sldId id="281" r:id="rId3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B9A7B02-3181-4E56-8641-1DCADC9EAE0B}" v="6" dt="2023-09-19T17:02:07.7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2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3B9A7B02-3181-4E56-8641-1DCADC9EAE0B}"/>
    <pc:docChg chg="custSel delSld modSld">
      <pc:chgData name="Chakraborty, Anirban" userId="beb374dd-c17a-4851-a293-48dd327a1c1a" providerId="ADAL" clId="{3B9A7B02-3181-4E56-8641-1DCADC9EAE0B}" dt="2023-09-19T17:02:30.153" v="51" actId="1037"/>
      <pc:docMkLst>
        <pc:docMk/>
      </pc:docMkLst>
      <pc:sldChg chg="del">
        <pc:chgData name="Chakraborty, Anirban" userId="beb374dd-c17a-4851-a293-48dd327a1c1a" providerId="ADAL" clId="{3B9A7B02-3181-4E56-8641-1DCADC9EAE0B}" dt="2023-09-19T13:23:00.531" v="0" actId="47"/>
        <pc:sldMkLst>
          <pc:docMk/>
          <pc:sldMk cId="1499400212" sldId="270"/>
        </pc:sldMkLst>
      </pc:sldChg>
      <pc:sldChg chg="del">
        <pc:chgData name="Chakraborty, Anirban" userId="beb374dd-c17a-4851-a293-48dd327a1c1a" providerId="ADAL" clId="{3B9A7B02-3181-4E56-8641-1DCADC9EAE0B}" dt="2023-09-19T13:23:00.531" v="0" actId="47"/>
        <pc:sldMkLst>
          <pc:docMk/>
          <pc:sldMk cId="1362357393" sldId="271"/>
        </pc:sldMkLst>
      </pc:sldChg>
      <pc:sldChg chg="del">
        <pc:chgData name="Chakraborty, Anirban" userId="beb374dd-c17a-4851-a293-48dd327a1c1a" providerId="ADAL" clId="{3B9A7B02-3181-4E56-8641-1DCADC9EAE0B}" dt="2023-09-19T13:23:00.531" v="0" actId="47"/>
        <pc:sldMkLst>
          <pc:docMk/>
          <pc:sldMk cId="3109744734" sldId="272"/>
        </pc:sldMkLst>
      </pc:sldChg>
      <pc:sldChg chg="del">
        <pc:chgData name="Chakraborty, Anirban" userId="beb374dd-c17a-4851-a293-48dd327a1c1a" providerId="ADAL" clId="{3B9A7B02-3181-4E56-8641-1DCADC9EAE0B}" dt="2023-09-19T13:23:04.669" v="1" actId="47"/>
        <pc:sldMkLst>
          <pc:docMk/>
          <pc:sldMk cId="3096922174" sldId="274"/>
        </pc:sldMkLst>
      </pc:sldChg>
      <pc:sldChg chg="del">
        <pc:chgData name="Chakraborty, Anirban" userId="beb374dd-c17a-4851-a293-48dd327a1c1a" providerId="ADAL" clId="{3B9A7B02-3181-4E56-8641-1DCADC9EAE0B}" dt="2023-09-19T13:23:00.531" v="0" actId="47"/>
        <pc:sldMkLst>
          <pc:docMk/>
          <pc:sldMk cId="2573754816" sldId="276"/>
        </pc:sldMkLst>
      </pc:sldChg>
      <pc:sldChg chg="del">
        <pc:chgData name="Chakraborty, Anirban" userId="beb374dd-c17a-4851-a293-48dd327a1c1a" providerId="ADAL" clId="{3B9A7B02-3181-4E56-8641-1DCADC9EAE0B}" dt="2023-09-19T13:23:00.531" v="0" actId="47"/>
        <pc:sldMkLst>
          <pc:docMk/>
          <pc:sldMk cId="550479794" sldId="278"/>
        </pc:sldMkLst>
      </pc:sldChg>
      <pc:sldChg chg="del">
        <pc:chgData name="Chakraborty, Anirban" userId="beb374dd-c17a-4851-a293-48dd327a1c1a" providerId="ADAL" clId="{3B9A7B02-3181-4E56-8641-1DCADC9EAE0B}" dt="2023-09-19T13:23:04.669" v="1" actId="47"/>
        <pc:sldMkLst>
          <pc:docMk/>
          <pc:sldMk cId="3002076954" sldId="279"/>
        </pc:sldMkLst>
      </pc:sldChg>
      <pc:sldChg chg="del">
        <pc:chgData name="Chakraborty, Anirban" userId="beb374dd-c17a-4851-a293-48dd327a1c1a" providerId="ADAL" clId="{3B9A7B02-3181-4E56-8641-1DCADC9EAE0B}" dt="2023-09-19T13:23:04.669" v="1" actId="47"/>
        <pc:sldMkLst>
          <pc:docMk/>
          <pc:sldMk cId="3852428335" sldId="280"/>
        </pc:sldMkLst>
      </pc:sldChg>
      <pc:sldChg chg="addSp delSp modSp mod">
        <pc:chgData name="Chakraborty, Anirban" userId="beb374dd-c17a-4851-a293-48dd327a1c1a" providerId="ADAL" clId="{3B9A7B02-3181-4E56-8641-1DCADC9EAE0B}" dt="2023-09-19T17:02:30.153" v="51" actId="1037"/>
        <pc:sldMkLst>
          <pc:docMk/>
          <pc:sldMk cId="1026364918" sldId="281"/>
        </pc:sldMkLst>
        <pc:spChg chg="del">
          <ac:chgData name="Chakraborty, Anirban" userId="beb374dd-c17a-4851-a293-48dd327a1c1a" providerId="ADAL" clId="{3B9A7B02-3181-4E56-8641-1DCADC9EAE0B}" dt="2023-09-19T13:25:38.186" v="3" actId="478"/>
          <ac:spMkLst>
            <pc:docMk/>
            <pc:sldMk cId="1026364918" sldId="281"/>
            <ac:spMk id="2" creationId="{00000000-0000-0000-0000-000000000000}"/>
          </ac:spMkLst>
        </pc:spChg>
        <pc:spChg chg="add mod">
          <ac:chgData name="Chakraborty, Anirban" userId="beb374dd-c17a-4851-a293-48dd327a1c1a" providerId="ADAL" clId="{3B9A7B02-3181-4E56-8641-1DCADC9EAE0B}" dt="2023-09-19T17:02:03.322" v="26" actId="1036"/>
          <ac:spMkLst>
            <pc:docMk/>
            <pc:sldMk cId="1026364918" sldId="281"/>
            <ac:spMk id="3" creationId="{F4D0B7E8-FE5F-2E81-9CAA-EAFE6B969F06}"/>
          </ac:spMkLst>
        </pc:spChg>
        <pc:spChg chg="add mod">
          <ac:chgData name="Chakraborty, Anirban" userId="beb374dd-c17a-4851-a293-48dd327a1c1a" providerId="ADAL" clId="{3B9A7B02-3181-4E56-8641-1DCADC9EAE0B}" dt="2023-09-19T17:02:26.204" v="50" actId="20577"/>
          <ac:spMkLst>
            <pc:docMk/>
            <pc:sldMk cId="1026364918" sldId="281"/>
            <ac:spMk id="4" creationId="{D8CBDEBA-697E-7B59-47DD-0E9FAAEA4EB9}"/>
          </ac:spMkLst>
        </pc:spChg>
        <pc:spChg chg="mod">
          <ac:chgData name="Chakraborty, Anirban" userId="beb374dd-c17a-4851-a293-48dd327a1c1a" providerId="ADAL" clId="{3B9A7B02-3181-4E56-8641-1DCADC9EAE0B}" dt="2023-09-19T17:02:30.153" v="51" actId="1037"/>
          <ac:spMkLst>
            <pc:docMk/>
            <pc:sldMk cId="1026364918" sldId="281"/>
            <ac:spMk id="38" creationId="{00000000-0000-0000-0000-000000000000}"/>
          </ac:spMkLst>
        </pc:spChg>
        <pc:spChg chg="mod ord">
          <ac:chgData name="Chakraborty, Anirban" userId="beb374dd-c17a-4851-a293-48dd327a1c1a" providerId="ADAL" clId="{3B9A7B02-3181-4E56-8641-1DCADC9EAE0B}" dt="2023-09-19T15:59:51.707" v="10" actId="14100"/>
          <ac:spMkLst>
            <pc:docMk/>
            <pc:sldMk cId="1026364918" sldId="281"/>
            <ac:spMk id="43" creationId="{00000000-0000-0000-0000-000000000000}"/>
          </ac:spMkLst>
        </pc:spChg>
        <pc:picChg chg="add mod">
          <ac:chgData name="Chakraborty, Anirban" userId="beb374dd-c17a-4851-a293-48dd327a1c1a" providerId="ADAL" clId="{3B9A7B02-3181-4E56-8641-1DCADC9EAE0B}" dt="2023-09-19T15:59:21.066" v="9" actId="1076"/>
          <ac:picMkLst>
            <pc:docMk/>
            <pc:sldMk cId="1026364918" sldId="281"/>
            <ac:picMk id="2" creationId="{7B2F2722-F4FD-ABA1-0D2A-EA4D079EA287}"/>
          </ac:picMkLst>
        </pc:picChg>
        <pc:picChg chg="del">
          <ac:chgData name="Chakraborty, Anirban" userId="beb374dd-c17a-4851-a293-48dd327a1c1a" providerId="ADAL" clId="{3B9A7B02-3181-4E56-8641-1DCADC9EAE0B}" dt="2023-09-19T15:58:57.426" v="5" actId="478"/>
          <ac:picMkLst>
            <pc:docMk/>
            <pc:sldMk cId="1026364918" sldId="281"/>
            <ac:picMk id="48" creationId="{00000000-0000-0000-0000-000000000000}"/>
          </ac:picMkLst>
        </pc:picChg>
      </pc:sldChg>
      <pc:sldChg chg="del">
        <pc:chgData name="Chakraborty, Anirban" userId="beb374dd-c17a-4851-a293-48dd327a1c1a" providerId="ADAL" clId="{3B9A7B02-3181-4E56-8641-1DCADC9EAE0B}" dt="2023-09-19T13:23:10.065" v="2" actId="47"/>
        <pc:sldMkLst>
          <pc:docMk/>
          <pc:sldMk cId="2329365240" sldId="282"/>
        </pc:sldMkLst>
      </pc:sldChg>
      <pc:sldChg chg="del">
        <pc:chgData name="Chakraborty, Anirban" userId="beb374dd-c17a-4851-a293-48dd327a1c1a" providerId="ADAL" clId="{3B9A7B02-3181-4E56-8641-1DCADC9EAE0B}" dt="2023-09-19T13:23:10.065" v="2" actId="47"/>
        <pc:sldMkLst>
          <pc:docMk/>
          <pc:sldMk cId="438658365" sldId="284"/>
        </pc:sldMkLst>
      </pc:sldChg>
      <pc:sldChg chg="del">
        <pc:chgData name="Chakraborty, Anirban" userId="beb374dd-c17a-4851-a293-48dd327a1c1a" providerId="ADAL" clId="{3B9A7B02-3181-4E56-8641-1DCADC9EAE0B}" dt="2023-09-19T13:23:04.669" v="1" actId="47"/>
        <pc:sldMkLst>
          <pc:docMk/>
          <pc:sldMk cId="1305156795" sldId="285"/>
        </pc:sldMkLst>
      </pc:sldChg>
      <pc:sldChg chg="modSp mod">
        <pc:chgData name="Chakraborty, Anirban" userId="beb374dd-c17a-4851-a293-48dd327a1c1a" providerId="ADAL" clId="{3B9A7B02-3181-4E56-8641-1DCADC9EAE0B}" dt="2023-09-19T13:55:08.742" v="4" actId="14100"/>
        <pc:sldMkLst>
          <pc:docMk/>
          <pc:sldMk cId="4028044274" sldId="286"/>
        </pc:sldMkLst>
        <pc:spChg chg="mod">
          <ac:chgData name="Chakraborty, Anirban" userId="beb374dd-c17a-4851-a293-48dd327a1c1a" providerId="ADAL" clId="{3B9A7B02-3181-4E56-8641-1DCADC9EAE0B}" dt="2023-09-19T13:55:08.742" v="4" actId="14100"/>
          <ac:spMkLst>
            <pc:docMk/>
            <pc:sldMk cId="4028044274" sldId="286"/>
            <ac:spMk id="6" creationId="{00000000-0000-0000-0000-000000000000}"/>
          </ac:spMkLst>
        </pc:spChg>
      </pc:sldChg>
      <pc:sldChg chg="del">
        <pc:chgData name="Chakraborty, Anirban" userId="beb374dd-c17a-4851-a293-48dd327a1c1a" providerId="ADAL" clId="{3B9A7B02-3181-4E56-8641-1DCADC9EAE0B}" dt="2023-09-19T13:23:10.065" v="2" actId="47"/>
        <pc:sldMkLst>
          <pc:docMk/>
          <pc:sldMk cId="256142667" sldId="287"/>
        </pc:sldMkLst>
      </pc:sldChg>
      <pc:sldChg chg="del">
        <pc:chgData name="Chakraborty, Anirban" userId="beb374dd-c17a-4851-a293-48dd327a1c1a" providerId="ADAL" clId="{3B9A7B02-3181-4E56-8641-1DCADC9EAE0B}" dt="2023-09-19T13:23:10.065" v="2" actId="47"/>
        <pc:sldMkLst>
          <pc:docMk/>
          <pc:sldMk cId="3421195017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1522" y="992124"/>
            <a:ext cx="5215128" cy="487375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86425" y="66675"/>
            <a:ext cx="90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4</a:t>
            </a:r>
          </a:p>
        </p:txBody>
      </p:sp>
      <p:sp>
        <p:nvSpPr>
          <p:cNvPr id="6" name="Rectangle 5"/>
          <p:cNvSpPr/>
          <p:nvPr/>
        </p:nvSpPr>
        <p:spPr>
          <a:xfrm>
            <a:off x="5335398" y="893207"/>
            <a:ext cx="4113402" cy="30406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044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4848225" y="72490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4B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4604114" y="1403016"/>
            <a:ext cx="178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ontrol </a:t>
            </a:r>
            <a:r>
              <a:rPr lang="en-US" sz="1400" dirty="0" err="1"/>
              <a:t>shRNA</a:t>
            </a:r>
            <a:endParaRPr lang="en-US" sz="1400" dirty="0"/>
          </a:p>
        </p:txBody>
      </p:sp>
      <p:sp>
        <p:nvSpPr>
          <p:cNvPr id="39" name="Right Triangle 38"/>
          <p:cNvSpPr/>
          <p:nvPr/>
        </p:nvSpPr>
        <p:spPr>
          <a:xfrm flipH="1">
            <a:off x="6087960" y="1783751"/>
            <a:ext cx="1367287" cy="173173"/>
          </a:xfrm>
          <a:prstGeom prst="rt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6087960" y="2008837"/>
            <a:ext cx="178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TXN3 </a:t>
            </a:r>
            <a:r>
              <a:rPr lang="en-US" sz="1400" dirty="0" err="1"/>
              <a:t>shRNA</a:t>
            </a:r>
            <a:endParaRPr lang="en-US" sz="1400" dirty="0"/>
          </a:p>
        </p:txBody>
      </p:sp>
      <p:cxnSp>
        <p:nvCxnSpPr>
          <p:cNvPr id="41" name="Straight Connector 40"/>
          <p:cNvCxnSpPr/>
          <p:nvPr/>
        </p:nvCxnSpPr>
        <p:spPr>
          <a:xfrm>
            <a:off x="5306472" y="1209675"/>
            <a:ext cx="21487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166558" y="809444"/>
            <a:ext cx="2623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uclear extract (200 </a:t>
            </a:r>
            <a:r>
              <a:rPr lang="en-US" dirty="0" err="1"/>
              <a:t>ng</a:t>
            </a:r>
            <a:r>
              <a:rPr lang="en-US" dirty="0"/>
              <a:t>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478059" y="4932774"/>
            <a:ext cx="180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087960" y="1370053"/>
            <a:ext cx="16161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-25-50-100 </a:t>
            </a:r>
            <a:r>
              <a:rPr lang="en-US" sz="1200" dirty="0" err="1"/>
              <a:t>fmole</a:t>
            </a:r>
            <a:r>
              <a:rPr lang="en-US" sz="1200" dirty="0"/>
              <a:t> Q29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5750874" y="2268515"/>
            <a:ext cx="16668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3"/>
          <p:cNvSpPr txBox="1">
            <a:spLocks noChangeArrowheads="1"/>
          </p:cNvSpPr>
          <p:nvPr/>
        </p:nvSpPr>
        <p:spPr bwMode="auto">
          <a:xfrm>
            <a:off x="4380679" y="2804881"/>
            <a:ext cx="32431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      1       2      3      4      5      6      7      8    </a:t>
            </a:r>
          </a:p>
        </p:txBody>
      </p:sp>
      <p:sp>
        <p:nvSpPr>
          <p:cNvPr id="50" name="TextBox 4"/>
          <p:cNvSpPr txBox="1">
            <a:spLocks noChangeArrowheads="1"/>
          </p:cNvSpPr>
          <p:nvPr/>
        </p:nvSpPr>
        <p:spPr bwMode="auto">
          <a:xfrm>
            <a:off x="4432925" y="2533650"/>
            <a:ext cx="30572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     -       +       -       -      -       -       -       -   </a:t>
            </a:r>
          </a:p>
        </p:txBody>
      </p:sp>
      <p:sp>
        <p:nvSpPr>
          <p:cNvPr id="51" name="TextBox 7"/>
          <p:cNvSpPr txBox="1">
            <a:spLocks noChangeArrowheads="1"/>
          </p:cNvSpPr>
          <p:nvPr/>
        </p:nvSpPr>
        <p:spPr bwMode="auto">
          <a:xfrm>
            <a:off x="3777612" y="2533650"/>
            <a:ext cx="603250" cy="2777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PNKP</a:t>
            </a:r>
          </a:p>
        </p:txBody>
      </p:sp>
      <p:sp>
        <p:nvSpPr>
          <p:cNvPr id="52" name="TextBox 8"/>
          <p:cNvSpPr txBox="1">
            <a:spLocks noChangeArrowheads="1"/>
          </p:cNvSpPr>
          <p:nvPr/>
        </p:nvSpPr>
        <p:spPr bwMode="auto">
          <a:xfrm>
            <a:off x="3607749" y="2228850"/>
            <a:ext cx="10100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ATXN3-Q29</a:t>
            </a:r>
          </a:p>
        </p:txBody>
      </p:sp>
      <p:sp>
        <p:nvSpPr>
          <p:cNvPr id="53" name="TextBox 12"/>
          <p:cNvSpPr txBox="1">
            <a:spLocks noChangeArrowheads="1"/>
          </p:cNvSpPr>
          <p:nvPr/>
        </p:nvSpPr>
        <p:spPr bwMode="auto">
          <a:xfrm>
            <a:off x="4633274" y="2256651"/>
            <a:ext cx="35052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-        -       -       -      +     ++   +++  ++++        </a:t>
            </a:r>
          </a:p>
        </p:txBody>
      </p:sp>
      <p:sp>
        <p:nvSpPr>
          <p:cNvPr id="54" name="TextBox 29"/>
          <p:cNvSpPr txBox="1">
            <a:spLocks noChangeArrowheads="1"/>
          </p:cNvSpPr>
          <p:nvPr/>
        </p:nvSpPr>
        <p:spPr bwMode="auto">
          <a:xfrm>
            <a:off x="3947474" y="3219450"/>
            <a:ext cx="287258" cy="276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S</a:t>
            </a:r>
          </a:p>
        </p:txBody>
      </p:sp>
      <p:sp>
        <p:nvSpPr>
          <p:cNvPr id="55" name="TextBox 30"/>
          <p:cNvSpPr txBox="1">
            <a:spLocks noChangeArrowheads="1"/>
          </p:cNvSpPr>
          <p:nvPr/>
        </p:nvSpPr>
        <p:spPr bwMode="auto">
          <a:xfrm>
            <a:off x="3965016" y="4362450"/>
            <a:ext cx="287258" cy="276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>
                <a:latin typeface="Arial" panose="020B0604020202020204" pitchFamily="34" charset="0"/>
              </a:rPr>
              <a:t>P</a:t>
            </a:r>
          </a:p>
        </p:txBody>
      </p:sp>
      <p:cxnSp>
        <p:nvCxnSpPr>
          <p:cNvPr id="56" name="Straight Connector 55"/>
          <p:cNvCxnSpPr/>
          <p:nvPr/>
        </p:nvCxnSpPr>
        <p:spPr bwMode="auto">
          <a:xfrm>
            <a:off x="4166549" y="3371850"/>
            <a:ext cx="228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 bwMode="auto">
          <a:xfrm>
            <a:off x="4166549" y="4514850"/>
            <a:ext cx="228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2">
            <a:extLst>
              <a:ext uri="{FF2B5EF4-FFF2-40B4-BE49-F238E27FC236}">
                <a16:creationId xmlns:a16="http://schemas.microsoft.com/office/drawing/2014/main" id="{7B2F2722-F4FD-ABA1-0D2A-EA4D079EA2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0" t="16000" b="34000"/>
          <a:stretch>
            <a:fillRect/>
          </a:stretch>
        </p:blipFill>
        <p:spPr bwMode="auto">
          <a:xfrm>
            <a:off x="4395149" y="3087648"/>
            <a:ext cx="3048000" cy="1905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Rectangle 42"/>
          <p:cNvSpPr/>
          <p:nvPr/>
        </p:nvSpPr>
        <p:spPr>
          <a:xfrm>
            <a:off x="4501355" y="3195592"/>
            <a:ext cx="2880421" cy="1651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D0B7E8-FE5F-2E81-9CAA-EAFE6B969F06}"/>
              </a:ext>
            </a:extLst>
          </p:cNvPr>
          <p:cNvSpPr txBox="1"/>
          <p:nvPr/>
        </p:nvSpPr>
        <p:spPr>
          <a:xfrm rot="16200000">
            <a:off x="3841988" y="1363878"/>
            <a:ext cx="178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 prote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CBDEBA-697E-7B59-47DD-0E9FAAEA4EB9}"/>
              </a:ext>
            </a:extLst>
          </p:cNvPr>
          <p:cNvSpPr txBox="1"/>
          <p:nvPr/>
        </p:nvSpPr>
        <p:spPr>
          <a:xfrm rot="16200000">
            <a:off x="4238234" y="1377510"/>
            <a:ext cx="178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NKP (purified)</a:t>
            </a:r>
          </a:p>
        </p:txBody>
      </p:sp>
    </p:spTree>
    <p:extLst>
      <p:ext uri="{BB962C8B-B14F-4D97-AF65-F5344CB8AC3E}">
        <p14:creationId xmlns:p14="http://schemas.microsoft.com/office/powerpoint/2010/main" val="1026364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2</TotalTime>
  <Words>58</Words>
  <Application>Microsoft Office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Chakraborty, Anirban</cp:lastModifiedBy>
  <cp:revision>151</cp:revision>
  <cp:lastPrinted>2023-08-29T23:30:28Z</cp:lastPrinted>
  <dcterms:created xsi:type="dcterms:W3CDTF">2021-02-24T12:59:59Z</dcterms:created>
  <dcterms:modified xsi:type="dcterms:W3CDTF">2023-09-19T17:02:31Z</dcterms:modified>
</cp:coreProperties>
</file>